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5.png" ContentType="image/png"/>
  <Override PartName="/ppt/media/image2.jpeg" ContentType="image/jpeg"/>
  <Override PartName="/ppt/media/image3.jpeg" ContentType="image/jpeg"/>
  <Override PartName="/ppt/media/image4.jpeg" ContentType="image/jpeg"/>
  <Override PartName="/ppt/media/image6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0E038E-E8D1-4DEB-85B7-8E7E2E33579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711C0C-B477-4B54-A70A-8D43D31039A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62F6F6-B1D4-444B-B061-C7D39802019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C58C0E-B918-4E47-9B69-265C64AB37C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1EBE8A-AE59-4E1B-97FD-83703947440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6AC27B-18EA-43E0-950F-CA270D5AF14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4862B5-A280-4A89-B7E5-C3DAC87F548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9FF8FD-F852-4831-9C17-DA26BC59DCF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CCD85D-85A9-4E01-A13A-5BD40FC1B10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C2D702-8054-4DA3-9207-73E0487F592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E662FB-49DF-4347-BF4C-05CA7E953A5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60B455-7438-465A-B599-6A19F74D563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C6EC0F1D-9A62-4924-8C1F-F5D16238A6C1}" type="datetime">
              <a:rPr b="0" lang="de-DE" sz="1200" spc="-1" strike="noStrike">
                <a:solidFill>
                  <a:srgbClr val="898989"/>
                </a:solidFill>
                <a:latin typeface="Calibri"/>
              </a:rPr>
              <a:t>29.08.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5FC16D56-6137-4553-94FD-B5548366C155}" type="slidenum">
              <a:rPr b="0" lang="de-DE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uppierung 11"/>
          <p:cNvGrpSpPr/>
          <p:nvPr/>
        </p:nvGrpSpPr>
        <p:grpSpPr>
          <a:xfrm>
            <a:off x="4572000" y="620640"/>
            <a:ext cx="3922560" cy="2919600"/>
            <a:chOff x="4572000" y="620640"/>
            <a:chExt cx="3922560" cy="2919600"/>
          </a:xfrm>
        </p:grpSpPr>
        <p:pic>
          <p:nvPicPr>
            <p:cNvPr id="42" name="Grafik 10" descr="%CD38CD8 or CD95Cd4 nouna crntl vs gender.jpg"/>
            <p:cNvPicPr/>
            <p:nvPr/>
          </p:nvPicPr>
          <p:blipFill>
            <a:blip r:embed="rId1"/>
            <a:stretch/>
          </p:blipFill>
          <p:spPr>
            <a:xfrm>
              <a:off x="4572000" y="620640"/>
              <a:ext cx="3922560" cy="29196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3" name="Textfeld 23"/>
            <p:cNvSpPr/>
            <p:nvPr/>
          </p:nvSpPr>
          <p:spPr>
            <a:xfrm>
              <a:off x="5313600" y="755280"/>
              <a:ext cx="3088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de-DE" sz="18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4" name="Gruppierung 13"/>
          <p:cNvGrpSpPr/>
          <p:nvPr/>
        </p:nvGrpSpPr>
        <p:grpSpPr>
          <a:xfrm>
            <a:off x="395280" y="3716280"/>
            <a:ext cx="3895560" cy="2881440"/>
            <a:chOff x="395280" y="3716280"/>
            <a:chExt cx="3895560" cy="2881440"/>
          </a:xfrm>
        </p:grpSpPr>
        <p:pic>
          <p:nvPicPr>
            <p:cNvPr id="45" name="Grafik 6" descr="ABCCD38CD95 vs ender Nouna Cntrl.jpg"/>
            <p:cNvPicPr/>
            <p:nvPr/>
          </p:nvPicPr>
          <p:blipFill>
            <a:blip r:embed="rId2"/>
            <a:stretch/>
          </p:blipFill>
          <p:spPr>
            <a:xfrm>
              <a:off x="395280" y="3716280"/>
              <a:ext cx="3895560" cy="28814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6" name="Textfeld 24"/>
            <p:cNvSpPr/>
            <p:nvPr/>
          </p:nvSpPr>
          <p:spPr>
            <a:xfrm>
              <a:off x="996120" y="3789000"/>
              <a:ext cx="3009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de-DE" sz="1800" spc="-1" strike="noStrike">
                  <a:solidFill>
                    <a:srgbClr val="000000"/>
                  </a:solidFill>
                  <a:latin typeface="Calibri"/>
                </a:rPr>
                <a:t>C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7" name="Gruppierung 12"/>
          <p:cNvGrpSpPr/>
          <p:nvPr/>
        </p:nvGrpSpPr>
        <p:grpSpPr>
          <a:xfrm>
            <a:off x="5035680" y="3465360"/>
            <a:ext cx="3568680" cy="3203640"/>
            <a:chOff x="5035680" y="3465360"/>
            <a:chExt cx="3568680" cy="3203640"/>
          </a:xfrm>
        </p:grpSpPr>
        <p:pic>
          <p:nvPicPr>
            <p:cNvPr id="48" name="Grafik 8" descr="ABCCD95dim vs gender Nouna.jpg"/>
            <p:cNvPicPr/>
            <p:nvPr/>
          </p:nvPicPr>
          <p:blipFill>
            <a:blip r:embed="rId3"/>
            <a:stretch/>
          </p:blipFill>
          <p:spPr>
            <a:xfrm>
              <a:off x="5035680" y="3465360"/>
              <a:ext cx="3568680" cy="32036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9" name="Textfeld 25"/>
            <p:cNvSpPr/>
            <p:nvPr/>
          </p:nvSpPr>
          <p:spPr>
            <a:xfrm>
              <a:off x="5376600" y="3715920"/>
              <a:ext cx="3254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de-DE" sz="1800" spc="-1" strike="noStrike">
                  <a:solidFill>
                    <a:srgbClr val="000000"/>
                  </a:solidFill>
                  <a:latin typeface="Calibri"/>
                </a:rPr>
                <a:t>D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0" name="Textfeld 5"/>
          <p:cNvSpPr/>
          <p:nvPr/>
        </p:nvSpPr>
        <p:spPr>
          <a:xfrm>
            <a:off x="324000" y="189000"/>
            <a:ext cx="79200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Times New Roman"/>
              </a:rPr>
              <a:t>Supplementary material d. </a:t>
            </a:r>
            <a:r>
              <a:rPr b="0" lang="de-DE" sz="1200" spc="-1" strike="noStrike">
                <a:solidFill>
                  <a:srgbClr val="000000"/>
                </a:solidFill>
                <a:latin typeface="Times New Roman"/>
              </a:rPr>
              <a:t>No gender-related differences in the percentage of naive and activated T cells or expression levels of T cell activation markers in healthy adults living in Nouna (rural Burkina Faso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feld 21"/>
          <p:cNvSpPr/>
          <p:nvPr/>
        </p:nvSpPr>
        <p:spPr>
          <a:xfrm>
            <a:off x="3645720" y="6488280"/>
            <a:ext cx="2126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Calibri"/>
              </a:rPr>
              <a:t>F – female, M – mal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2" name="Gruppieren 22"/>
          <p:cNvGrpSpPr/>
          <p:nvPr/>
        </p:nvGrpSpPr>
        <p:grpSpPr>
          <a:xfrm>
            <a:off x="533520" y="692280"/>
            <a:ext cx="3495600" cy="2746080"/>
            <a:chOff x="533520" y="692280"/>
            <a:chExt cx="3495600" cy="2746080"/>
          </a:xfrm>
        </p:grpSpPr>
        <p:grpSp>
          <p:nvGrpSpPr>
            <p:cNvPr id="53" name="Gruppieren 19"/>
            <p:cNvGrpSpPr/>
            <p:nvPr/>
          </p:nvGrpSpPr>
          <p:grpSpPr>
            <a:xfrm>
              <a:off x="533520" y="917640"/>
              <a:ext cx="3495600" cy="2520720"/>
              <a:chOff x="533520" y="917640"/>
              <a:chExt cx="3495600" cy="2520720"/>
            </a:xfrm>
          </p:grpSpPr>
          <p:pic>
            <p:nvPicPr>
              <p:cNvPr id="54" name="Grafik 2" descr="% Naive CD4_CD8 per Gender in nouna control.jpg"/>
              <p:cNvPicPr/>
              <p:nvPr/>
            </p:nvPicPr>
            <p:blipFill>
              <a:blip r:embed="rId4"/>
              <a:srcRect l="0" t="14217" r="0" b="12816"/>
              <a:stretch/>
            </p:blipFill>
            <p:spPr>
              <a:xfrm>
                <a:off x="533520" y="917640"/>
                <a:ext cx="3495600" cy="22327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55" name="Picture 16" descr=""/>
              <p:cNvPicPr/>
              <p:nvPr/>
            </p:nvPicPr>
            <p:blipFill>
              <a:blip r:embed="rId5"/>
              <a:srcRect l="67860" t="85116" r="4365" b="3194"/>
              <a:stretch/>
            </p:blipFill>
            <p:spPr>
              <a:xfrm>
                <a:off x="2844000" y="3078360"/>
                <a:ext cx="1008000" cy="3600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56" name="Picture 17" descr=""/>
              <p:cNvPicPr/>
              <p:nvPr/>
            </p:nvPicPr>
            <p:blipFill>
              <a:blip r:embed="rId6"/>
              <a:srcRect l="67860" t="85116" r="4365" b="3194"/>
              <a:stretch/>
            </p:blipFill>
            <p:spPr>
              <a:xfrm>
                <a:off x="1403640" y="3078360"/>
                <a:ext cx="1008000" cy="360000"/>
              </a:xfrm>
              <a:prstGeom prst="rect">
                <a:avLst/>
              </a:prstGeom>
              <a:ln w="0">
                <a:noFill/>
              </a:ln>
            </p:spPr>
          </p:pic>
        </p:grpSp>
        <p:sp>
          <p:nvSpPr>
            <p:cNvPr id="57" name="Textfeld 20"/>
            <p:cNvSpPr/>
            <p:nvPr/>
          </p:nvSpPr>
          <p:spPr>
            <a:xfrm>
              <a:off x="915480" y="692280"/>
              <a:ext cx="3193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de-DE" sz="1800" spc="-1" strike="noStrike">
                  <a:solidFill>
                    <a:srgbClr val="000000"/>
                  </a:solidFill>
                  <a:latin typeface="Calibri"/>
                </a:rPr>
                <a:t>A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7-14T04:58:58Z</dcterms:created>
  <dc:creator>Tiba Fabrice</dc:creator>
  <dc:description/>
  <dc:language>en-US</dc:language>
  <cp:lastModifiedBy>LG</cp:lastModifiedBy>
  <dcterms:modified xsi:type="dcterms:W3CDTF">2011-11-04T16:40:56Z</dcterms:modified>
  <cp:revision>3</cp:revision>
  <dc:subject/>
  <dc:title>Folie 1</dc:title>
</cp:coreProperties>
</file>